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0564BF-EE18-4856-B843-4225F1ADA35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4EC788-D4D3-4265-BECB-C486D82FA8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5526E2-9840-4A37-99C9-84355E5CBCA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603339-C9B7-4916-8E1D-8F7BC519312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117C00-BD96-45BC-9F54-F9355248875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3D837D-506E-4399-BC0A-624E7531A9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E4F0F2-E710-4D10-AFC6-9184FDBA78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4C1E0A-CBC6-4735-B185-86252A62F6B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6CE28D-2058-4603-9EC8-E102DEAEEC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0C4C1F-5286-4C1D-B40B-464A1AF086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35D37B-1129-44A0-8AAB-7260423440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F73AE9-3774-4A89-BCB9-10E0844131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AD988C2-CC9E-4483-B116-F9EECECA46B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5"/>
          <p:cNvSpPr/>
          <p:nvPr/>
        </p:nvSpPr>
        <p:spPr>
          <a:xfrm>
            <a:off x="380880" y="1314360"/>
            <a:ext cx="8686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CT    EF1α     18S     TUB  GAPDH  UK    F-BOX    L23     APR    PP2A    SAND   UBI3    GBP   SAMD   TIP41  PPR     RdR6   AGO2    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        b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12" descr="RM{F~YFAN@0NEGGXMREW{8C"/>
          <p:cNvPicPr/>
          <p:nvPr/>
        </p:nvPicPr>
        <p:blipFill>
          <a:blip r:embed="rId1"/>
          <a:stretch/>
        </p:blipFill>
        <p:spPr>
          <a:xfrm>
            <a:off x="343080" y="1554120"/>
            <a:ext cx="8343720" cy="132084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TOU[OV%R$FEL(IC_@648PIC"/>
          <p:cNvPicPr/>
          <p:nvPr/>
        </p:nvPicPr>
        <p:blipFill>
          <a:blip r:embed="rId2"/>
          <a:stretch/>
        </p:blipFill>
        <p:spPr>
          <a:xfrm>
            <a:off x="309600" y="3860640"/>
            <a:ext cx="8343720" cy="1320840"/>
          </a:xfrm>
          <a:prstGeom prst="rect">
            <a:avLst/>
          </a:prstGeom>
          <a:ln w="0">
            <a:noFill/>
          </a:ln>
        </p:spPr>
      </p:pic>
      <p:sp>
        <p:nvSpPr>
          <p:cNvPr id="44" name="矩形 1"/>
          <p:cNvSpPr/>
          <p:nvPr/>
        </p:nvSpPr>
        <p:spPr>
          <a:xfrm>
            <a:off x="8612640" y="2633760"/>
            <a:ext cx="3207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矩形 8"/>
          <p:cNvSpPr/>
          <p:nvPr/>
        </p:nvSpPr>
        <p:spPr>
          <a:xfrm>
            <a:off x="8613360" y="2195640"/>
            <a:ext cx="390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矩形 9"/>
          <p:cNvSpPr/>
          <p:nvPr/>
        </p:nvSpPr>
        <p:spPr>
          <a:xfrm>
            <a:off x="8613360" y="1957320"/>
            <a:ext cx="390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矩形 10"/>
          <p:cNvSpPr/>
          <p:nvPr/>
        </p:nvSpPr>
        <p:spPr>
          <a:xfrm>
            <a:off x="8613360" y="1739880"/>
            <a:ext cx="390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矩形 11"/>
          <p:cNvSpPr/>
          <p:nvPr/>
        </p:nvSpPr>
        <p:spPr>
          <a:xfrm>
            <a:off x="8613360" y="1590840"/>
            <a:ext cx="390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5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矩形 2"/>
          <p:cNvSpPr/>
          <p:nvPr/>
        </p:nvSpPr>
        <p:spPr>
          <a:xfrm>
            <a:off x="155160" y="8492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5"/>
          <p:cNvSpPr/>
          <p:nvPr/>
        </p:nvSpPr>
        <p:spPr>
          <a:xfrm>
            <a:off x="380880" y="3598920"/>
            <a:ext cx="8626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CT    EF1α     18S     TUB  GAPDH  UK   F-BOX    L23   APR    PP2A    SAND  UBI3    GBP    SAMD    TIP41   PPR     RdR6    AGO2     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矩形 14"/>
          <p:cNvSpPr/>
          <p:nvPr/>
        </p:nvSpPr>
        <p:spPr>
          <a:xfrm>
            <a:off x="154800" y="319248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19T11:02:56Z</dcterms:created>
  <dc:creator>j</dc:creator>
  <dc:description/>
  <dc:language>en-US</dc:language>
  <cp:lastModifiedBy>张永亮</cp:lastModifiedBy>
  <dcterms:modified xsi:type="dcterms:W3CDTF">2012-08-14T08:44:11Z</dcterms:modified>
  <cp:revision>14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